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925" autoAdjust="0"/>
    <p:restoredTop sz="86799" autoAdjust="0"/>
  </p:normalViewPr>
  <p:slideViewPr>
    <p:cSldViewPr snapToGrid="0">
      <p:cViewPr varScale="1">
        <p:scale>
          <a:sx n="75" d="100"/>
          <a:sy n="75" d="100"/>
        </p:scale>
        <p:origin x="2021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ieliangzhou\Desktop\Data%20for%20Supplemantary%20figu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ieliangzhou\Desktop\Data%20for%20Supplemantary%20figu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jieliangzhou\Desktop\Data%20for%20Supplemantary%20figur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75000"/>
              </a:schemeClr>
            </a:solidFill>
            <a:ln>
              <a:noFill/>
            </a:ln>
            <a:effectLst/>
          </c:spPr>
          <c:invertIfNegative val="0"/>
          <c:dPt>
            <c:idx val="5"/>
            <c:invertIfNegative val="0"/>
            <c:bubble3D val="0"/>
            <c:spPr>
              <a:solidFill>
                <a:srgbClr val="F7A44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535C-4298-BC78-856DEDBEB8E0}"/>
              </c:ext>
            </c:extLst>
          </c:dPt>
          <c:dPt>
            <c:idx val="6"/>
            <c:invertIfNegative val="0"/>
            <c:bubble3D val="0"/>
            <c:spPr>
              <a:solidFill>
                <a:srgbClr val="F7A44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535C-4298-BC78-856DEDBEB8E0}"/>
              </c:ext>
            </c:extLst>
          </c:dPt>
          <c:dPt>
            <c:idx val="7"/>
            <c:invertIfNegative val="0"/>
            <c:bubble3D val="0"/>
            <c:spPr>
              <a:solidFill>
                <a:srgbClr val="F7A445"/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535C-4298-BC78-856DEDBEB8E0}"/>
              </c:ext>
            </c:extLst>
          </c:dPt>
          <c:cat>
            <c:strRef>
              <c:f>'[Data for Supplemantary figure.xlsx]Sheet1'!$B$5:$I$5</c:f>
              <c:strCache>
                <c:ptCount val="8"/>
                <c:pt idx="0">
                  <c:v>IL-3</c:v>
                </c:pt>
                <c:pt idx="1">
                  <c:v>IL-16</c:v>
                </c:pt>
                <c:pt idx="2">
                  <c:v>HGF</c:v>
                </c:pt>
                <c:pt idx="3">
                  <c:v>IFN-a2</c:v>
                </c:pt>
                <c:pt idx="4">
                  <c:v>MCP-3</c:v>
                </c:pt>
                <c:pt idx="5">
                  <c:v>IL-12P70</c:v>
                </c:pt>
                <c:pt idx="6">
                  <c:v>MIP-1β</c:v>
                </c:pt>
                <c:pt idx="7">
                  <c:v>VEGF</c:v>
                </c:pt>
              </c:strCache>
            </c:strRef>
          </c:cat>
          <c:val>
            <c:numRef>
              <c:f>'[Data for Supplemantary figure.xlsx]Sheet1'!$B$6:$I$6</c:f>
              <c:numCache>
                <c:formatCode>General</c:formatCode>
                <c:ptCount val="8"/>
                <c:pt idx="0">
                  <c:v>-2.6210420000000002E-2</c:v>
                </c:pt>
                <c:pt idx="1">
                  <c:v>-2.1136930000000002E-2</c:v>
                </c:pt>
                <c:pt idx="2">
                  <c:v>-3.9081360000000002E-2</c:v>
                </c:pt>
                <c:pt idx="3">
                  <c:v>-1.4465820000000001E-2</c:v>
                </c:pt>
                <c:pt idx="4">
                  <c:v>-5.4643829999999997E-2</c:v>
                </c:pt>
                <c:pt idx="5">
                  <c:v>2.13104E-2</c:v>
                </c:pt>
                <c:pt idx="6">
                  <c:v>2.8573040000000001E-2</c:v>
                </c:pt>
                <c:pt idx="7">
                  <c:v>2.4947649999999998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535C-4298-BC78-856DEDBEB8E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overlap val="-27"/>
        <c:axId val="-725900688"/>
        <c:axId val="-725900160"/>
      </c:barChart>
      <c:catAx>
        <c:axId val="-725900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725900160"/>
        <c:crosses val="autoZero"/>
        <c:auto val="1"/>
        <c:lblAlgn val="ctr"/>
        <c:lblOffset val="100"/>
        <c:noMultiLvlLbl val="0"/>
      </c:catAx>
      <c:valAx>
        <c:axId val="-725900160"/>
        <c:scaling>
          <c:orientation val="minMax"/>
          <c:max val="0.03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725900688"/>
        <c:crosses val="autoZero"/>
        <c:crossBetween val="between"/>
        <c:majorUnit val="0.0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7A445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1-9989-4AD5-94AE-2883DC865C07}"/>
              </c:ext>
            </c:extLst>
          </c:dPt>
          <c:dPt>
            <c:idx val="1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9989-4AD5-94AE-2883DC865C07}"/>
              </c:ext>
            </c:extLst>
          </c:dPt>
          <c:dPt>
            <c:idx val="2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5-9989-4AD5-94AE-2883DC865C07}"/>
              </c:ext>
            </c:extLst>
          </c:dPt>
          <c:dPt>
            <c:idx val="3"/>
            <c:invertIfNegative val="0"/>
            <c:bubble3D val="0"/>
            <c:spPr>
              <a:solidFill>
                <a:schemeClr val="bg1">
                  <a:lumMod val="75000"/>
                </a:schemeClr>
              </a:solidFill>
              <a:ln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7-9989-4AD5-94AE-2883DC865C07}"/>
              </c:ext>
            </c:extLst>
          </c:dPt>
          <c:cat>
            <c:strRef>
              <c:f>'[Data for Supplemantary figure.xlsx]Sheet1'!$B$3:$G$3</c:f>
              <c:strCache>
                <c:ptCount val="6"/>
                <c:pt idx="0">
                  <c:v>IL-1β</c:v>
                </c:pt>
                <c:pt idx="1">
                  <c:v>MCP-1</c:v>
                </c:pt>
                <c:pt idx="2">
                  <c:v>IL-18</c:v>
                </c:pt>
                <c:pt idx="3">
                  <c:v>MCP-3</c:v>
                </c:pt>
                <c:pt idx="4">
                  <c:v>SCF</c:v>
                </c:pt>
                <c:pt idx="5">
                  <c:v>SCGF-β</c:v>
                </c:pt>
              </c:strCache>
            </c:strRef>
          </c:cat>
          <c:val>
            <c:numRef>
              <c:f>'[Data for Supplemantary figure.xlsx]Sheet1'!$B$4:$G$4</c:f>
              <c:numCache>
                <c:formatCode>General</c:formatCode>
                <c:ptCount val="6"/>
                <c:pt idx="0">
                  <c:v>-1.305515E-2</c:v>
                </c:pt>
                <c:pt idx="1">
                  <c:v>-3.3364530000000003E-2</c:v>
                </c:pt>
                <c:pt idx="2">
                  <c:v>-5.1475149999999997E-2</c:v>
                </c:pt>
                <c:pt idx="3">
                  <c:v>-2.86754E-2</c:v>
                </c:pt>
                <c:pt idx="4">
                  <c:v>1.8354970000000002E-2</c:v>
                </c:pt>
                <c:pt idx="5">
                  <c:v>-7.2371659999999997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9989-4AD5-94AE-2883DC865C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5"/>
        <c:overlap val="-27"/>
        <c:axId val="-730388640"/>
        <c:axId val="-234237088"/>
      </c:barChart>
      <c:catAx>
        <c:axId val="-7303886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34237088"/>
        <c:crosses val="autoZero"/>
        <c:auto val="1"/>
        <c:lblAlgn val="ctr"/>
        <c:lblOffset val="100"/>
        <c:noMultiLvlLbl val="0"/>
      </c:catAx>
      <c:valAx>
        <c:axId val="-23423708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730388640"/>
        <c:crosses val="autoZero"/>
        <c:crossBetween val="between"/>
        <c:majorUnit val="0.0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F7A445"/>
            </a:solidFill>
            <a:ln>
              <a:noFill/>
            </a:ln>
            <a:effectLst/>
          </c:spPr>
          <c:invertIfNegative val="0"/>
          <c:cat>
            <c:strRef>
              <c:f>'[Data for Supplemantary figure.xlsx]Sheet1'!$B$1:$C$1</c:f>
              <c:strCache>
                <c:ptCount val="2"/>
                <c:pt idx="0">
                  <c:v>IL-12P70</c:v>
                </c:pt>
                <c:pt idx="1">
                  <c:v>CTACK</c:v>
                </c:pt>
              </c:strCache>
            </c:strRef>
          </c:cat>
          <c:val>
            <c:numRef>
              <c:f>'[Data for Supplemantary figure.xlsx]Sheet1'!$B$2:$C$2</c:f>
              <c:numCache>
                <c:formatCode>General</c:formatCode>
                <c:ptCount val="2"/>
                <c:pt idx="0">
                  <c:v>1.7556539999999999E-2</c:v>
                </c:pt>
                <c:pt idx="1">
                  <c:v>2.3829250000000001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CBD-48B0-842C-ECE601E93ED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40"/>
        <c:overlap val="-27"/>
        <c:axId val="-729856688"/>
        <c:axId val="-725898864"/>
      </c:barChart>
      <c:catAx>
        <c:axId val="-729856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725898864"/>
        <c:crosses val="autoZero"/>
        <c:auto val="1"/>
        <c:lblAlgn val="ctr"/>
        <c:lblOffset val="100"/>
        <c:noMultiLvlLbl val="0"/>
      </c:catAx>
      <c:valAx>
        <c:axId val="-72589886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60000" spcFirstLastPara="1" vertOverflow="ellipsis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729856688"/>
        <c:crosses val="autoZero"/>
        <c:crossBetween val="between"/>
        <c:majorUnit val="8.0000000000000002E-3"/>
        <c:minorUnit val="2E-3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F1721D-21FA-4CC2-A398-7B6FA3A445D7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SG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54B5B42-B6CE-450A-B3EF-5ABFC199D6FB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1104793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dirty="0"/>
              <a:t>Figure S1. Partial Least Squares Regression analysis of endometriosis severity. Loadings plots of (A) Endometriosis-free controls (EM-) versus women with ASRM Stage I/II endometriosis (</a:t>
            </a:r>
            <a:r>
              <a:rPr lang="en-SG" dirty="0" err="1"/>
              <a:t>EM+</a:t>
            </a:r>
            <a:r>
              <a:rPr lang="en-SG" baseline="-25000" dirty="0" err="1"/>
              <a:t>Mild</a:t>
            </a:r>
            <a:r>
              <a:rPr lang="en-SG" dirty="0"/>
              <a:t>), (B) EM- versus women with Stage III/IV endometriosis (</a:t>
            </a:r>
            <a:r>
              <a:rPr lang="en-SG" dirty="0" err="1"/>
              <a:t>EM+</a:t>
            </a:r>
            <a:r>
              <a:rPr lang="en-SG" baseline="-25000" dirty="0" err="1"/>
              <a:t>Severe</a:t>
            </a:r>
            <a:r>
              <a:rPr lang="en-SG" dirty="0"/>
              <a:t>), and (C) </a:t>
            </a:r>
            <a:r>
              <a:rPr lang="en-SG" dirty="0" err="1"/>
              <a:t>EM+</a:t>
            </a:r>
            <a:r>
              <a:rPr lang="en-SG" baseline="-25000" dirty="0" err="1"/>
              <a:t>Mild</a:t>
            </a:r>
            <a:r>
              <a:rPr lang="en-SG" dirty="0"/>
              <a:t> versus </a:t>
            </a:r>
            <a:r>
              <a:rPr lang="en-SG" dirty="0" err="1"/>
              <a:t>EM+</a:t>
            </a:r>
            <a:r>
              <a:rPr lang="en-SG" baseline="-25000" dirty="0" err="1"/>
              <a:t>Severe</a:t>
            </a:r>
            <a:r>
              <a:rPr lang="en-SG" dirty="0"/>
              <a:t>. (D – F) Corresponding PLSR Coefficient analysis of significant cytokine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4B5B42-B6CE-450A-B3EF-5ABFC199D6FB}" type="slidenum">
              <a:rPr lang="en-SG" smtClean="0"/>
              <a:t>1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753407030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SG" dirty="0"/>
              <a:t>Figure S2. PLSR scores plot showing the delineation of peritoneal endometriosis (PE), ovarian endometrioma (OE) and deep infiltrating endometriosis (DIE) by their peritoneal fluid cytokine profiles.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54B5B42-B6CE-450A-B3EF-5ABFC199D6FB}" type="slidenum">
              <a:rPr lang="en-SG" smtClean="0"/>
              <a:t>2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386276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6320811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514556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4565430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2231872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613078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4366018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3054671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1073928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2445223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4589051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G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294819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66A19E-B7AF-4FE4-BC6F-FB5818D29B63}" type="datetimeFigureOut">
              <a:rPr lang="en-SG" smtClean="0"/>
              <a:t>24/7/2019</a:t>
            </a:fld>
            <a:endParaRPr lang="en-SG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SG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0065F-3DB4-4D67-AF0B-D338E2199FB3}" type="slidenum">
              <a:rPr lang="en-SG" smtClean="0"/>
              <a:t>‹#›</a:t>
            </a:fld>
            <a:endParaRPr lang="en-SG"/>
          </a:p>
        </p:txBody>
      </p:sp>
    </p:spTree>
    <p:extLst>
      <p:ext uri="{BB962C8B-B14F-4D97-AF65-F5344CB8AC3E}">
        <p14:creationId xmlns:p14="http://schemas.microsoft.com/office/powerpoint/2010/main" val="25601821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3.xml"/><Relationship Id="rId3" Type="http://schemas.openxmlformats.org/officeDocument/2006/relationships/chart" Target="../charts/chart1.xml"/><Relationship Id="rId7" Type="http://schemas.openxmlformats.org/officeDocument/2006/relationships/chart" Target="../charts/chart2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emf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6" name="Chart 35">
            <a:extLst>
              <a:ext uri="{FF2B5EF4-FFF2-40B4-BE49-F238E27FC236}">
                <a16:creationId xmlns:a16="http://schemas.microsoft.com/office/drawing/2014/main" id="{E432E2BF-D9AB-4E43-B640-8069086CF4C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9935242"/>
              </p:ext>
            </p:extLst>
          </p:nvPr>
        </p:nvGraphicFramePr>
        <p:xfrm>
          <a:off x="36814" y="3942934"/>
          <a:ext cx="3211331" cy="24851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8" name="Picture 2">
            <a:extLst>
              <a:ext uri="{FF2B5EF4-FFF2-40B4-BE49-F238E27FC236}">
                <a16:creationId xmlns:a16="http://schemas.microsoft.com/office/drawing/2014/main" id="{23E7DC34-0E89-42E0-9BAF-05511720F18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print"/>
          <a:srcRect t="5451" r="15619"/>
          <a:stretch/>
        </p:blipFill>
        <p:spPr bwMode="auto">
          <a:xfrm>
            <a:off x="129466" y="662878"/>
            <a:ext cx="2932676" cy="284612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9" name="Group 8">
            <a:extLst>
              <a:ext uri="{FF2B5EF4-FFF2-40B4-BE49-F238E27FC236}">
                <a16:creationId xmlns:a16="http://schemas.microsoft.com/office/drawing/2014/main" id="{5200FB63-3D52-4CA2-86C8-245CACB927AA}"/>
              </a:ext>
            </a:extLst>
          </p:cNvPr>
          <p:cNvGrpSpPr/>
          <p:nvPr/>
        </p:nvGrpSpPr>
        <p:grpSpPr>
          <a:xfrm>
            <a:off x="2204558" y="446206"/>
            <a:ext cx="700089" cy="400110"/>
            <a:chOff x="2895600" y="381000"/>
            <a:chExt cx="700089" cy="400110"/>
          </a:xfrm>
        </p:grpSpPr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4A98721-5436-42DF-8456-942E97560A34}"/>
                </a:ext>
              </a:extLst>
            </p:cNvPr>
            <p:cNvSpPr txBox="1"/>
            <p:nvPr/>
          </p:nvSpPr>
          <p:spPr>
            <a:xfrm>
              <a:off x="2971800" y="381000"/>
              <a:ext cx="62388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+</a:t>
              </a:r>
              <a:r>
                <a:rPr lang="en-US" sz="10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Mild</a:t>
              </a:r>
              <a:endPara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M-</a:t>
              </a: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6C4CF3AD-FA08-4A21-8FD7-2B0BDD022775}"/>
                </a:ext>
              </a:extLst>
            </p:cNvPr>
            <p:cNvSpPr/>
            <p:nvPr/>
          </p:nvSpPr>
          <p:spPr>
            <a:xfrm>
              <a:off x="2895600" y="457200"/>
              <a:ext cx="64008" cy="64008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99F200BE-C1A0-4BCE-90B2-B5E2CE447D34}"/>
                </a:ext>
              </a:extLst>
            </p:cNvPr>
            <p:cNvSpPr/>
            <p:nvPr/>
          </p:nvSpPr>
          <p:spPr>
            <a:xfrm>
              <a:off x="2895600" y="609600"/>
              <a:ext cx="64008" cy="6400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" name="Picture 3">
            <a:extLst>
              <a:ext uri="{FF2B5EF4-FFF2-40B4-BE49-F238E27FC236}">
                <a16:creationId xmlns:a16="http://schemas.microsoft.com/office/drawing/2014/main" id="{306C8FAE-767B-4A24-9DAD-AC659046A14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print"/>
          <a:srcRect t="3672"/>
          <a:stretch/>
        </p:blipFill>
        <p:spPr bwMode="auto">
          <a:xfrm>
            <a:off x="3111751" y="455454"/>
            <a:ext cx="2950885" cy="3013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" name="Picture 3">
            <a:extLst>
              <a:ext uri="{FF2B5EF4-FFF2-40B4-BE49-F238E27FC236}">
                <a16:creationId xmlns:a16="http://schemas.microsoft.com/office/drawing/2014/main" id="{D6844CD3-10BE-43F1-AE7F-7725C399125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6" cstate="print"/>
          <a:srcRect t="3681"/>
          <a:stretch/>
        </p:blipFill>
        <p:spPr bwMode="auto">
          <a:xfrm>
            <a:off x="6004405" y="490155"/>
            <a:ext cx="3139595" cy="301336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grpSp>
        <p:nvGrpSpPr>
          <p:cNvPr id="15" name="Group 14">
            <a:extLst>
              <a:ext uri="{FF2B5EF4-FFF2-40B4-BE49-F238E27FC236}">
                <a16:creationId xmlns:a16="http://schemas.microsoft.com/office/drawing/2014/main" id="{9D2F22A7-D1EA-4811-8E12-B6E82BEB0D1F}"/>
              </a:ext>
            </a:extLst>
          </p:cNvPr>
          <p:cNvGrpSpPr/>
          <p:nvPr/>
        </p:nvGrpSpPr>
        <p:grpSpPr>
          <a:xfrm>
            <a:off x="8196998" y="432979"/>
            <a:ext cx="812299" cy="400110"/>
            <a:chOff x="2895600" y="381000"/>
            <a:chExt cx="812299" cy="400110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31A99FBD-C819-4185-87D6-5F80DEB8A25D}"/>
                </a:ext>
              </a:extLst>
            </p:cNvPr>
            <p:cNvSpPr txBox="1"/>
            <p:nvPr/>
          </p:nvSpPr>
          <p:spPr>
            <a:xfrm>
              <a:off x="2971800" y="381000"/>
              <a:ext cx="7360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+</a:t>
              </a:r>
              <a:r>
                <a:rPr lang="en-US" sz="10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endPara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+</a:t>
              </a:r>
              <a:r>
                <a:rPr lang="en-US" sz="10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Mild</a:t>
              </a:r>
              <a:endPara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E988EB2D-8E7D-4563-99FE-F6645F6FFC61}"/>
                </a:ext>
              </a:extLst>
            </p:cNvPr>
            <p:cNvSpPr/>
            <p:nvPr/>
          </p:nvSpPr>
          <p:spPr>
            <a:xfrm>
              <a:off x="2895600" y="457200"/>
              <a:ext cx="64008" cy="64008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Oval 17">
              <a:extLst>
                <a:ext uri="{FF2B5EF4-FFF2-40B4-BE49-F238E27FC236}">
                  <a16:creationId xmlns:a16="http://schemas.microsoft.com/office/drawing/2014/main" id="{D5EC52FF-859F-421A-A8E8-183FC43E544A}"/>
                </a:ext>
              </a:extLst>
            </p:cNvPr>
            <p:cNvSpPr/>
            <p:nvPr/>
          </p:nvSpPr>
          <p:spPr>
            <a:xfrm>
              <a:off x="2895600" y="609600"/>
              <a:ext cx="64008" cy="6400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9" name="Group 18">
            <a:extLst>
              <a:ext uri="{FF2B5EF4-FFF2-40B4-BE49-F238E27FC236}">
                <a16:creationId xmlns:a16="http://schemas.microsoft.com/office/drawing/2014/main" id="{0C1663FA-17E3-4230-9A76-5E8B588101B2}"/>
              </a:ext>
            </a:extLst>
          </p:cNvPr>
          <p:cNvGrpSpPr/>
          <p:nvPr/>
        </p:nvGrpSpPr>
        <p:grpSpPr>
          <a:xfrm>
            <a:off x="5110802" y="401202"/>
            <a:ext cx="812299" cy="400110"/>
            <a:chOff x="2895600" y="381000"/>
            <a:chExt cx="812299" cy="400110"/>
          </a:xfrm>
        </p:grpSpPr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9FCC67AD-AD53-4899-97F4-F9AAA6D7AD53}"/>
                </a:ext>
              </a:extLst>
            </p:cNvPr>
            <p:cNvSpPr txBox="1"/>
            <p:nvPr/>
          </p:nvSpPr>
          <p:spPr>
            <a:xfrm>
              <a:off x="2971800" y="381000"/>
              <a:ext cx="736099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EM+</a:t>
              </a:r>
              <a:r>
                <a:rPr lang="en-US" sz="1000" b="1" baseline="-25000" dirty="0" err="1">
                  <a:latin typeface="Arial" panose="020B0604020202020204" pitchFamily="34" charset="0"/>
                  <a:cs typeface="Arial" panose="020B0604020202020204" pitchFamily="34" charset="0"/>
                </a:rPr>
                <a:t>Severe</a:t>
              </a:r>
              <a:endPara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EM-</a:t>
              </a:r>
              <a:endParaRPr lang="en-US" sz="10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id="{D91F48E0-35B8-49AE-8B55-4E7B1B806526}"/>
                </a:ext>
              </a:extLst>
            </p:cNvPr>
            <p:cNvSpPr/>
            <p:nvPr/>
          </p:nvSpPr>
          <p:spPr>
            <a:xfrm>
              <a:off x="2895600" y="457200"/>
              <a:ext cx="64008" cy="64008"/>
            </a:xfrm>
            <a:prstGeom prst="rect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Oval 21">
              <a:extLst>
                <a:ext uri="{FF2B5EF4-FFF2-40B4-BE49-F238E27FC236}">
                  <a16:creationId xmlns:a16="http://schemas.microsoft.com/office/drawing/2014/main" id="{8E694E9E-CDD9-4C49-854F-400078EC288E}"/>
                </a:ext>
              </a:extLst>
            </p:cNvPr>
            <p:cNvSpPr/>
            <p:nvPr/>
          </p:nvSpPr>
          <p:spPr>
            <a:xfrm>
              <a:off x="2895600" y="609600"/>
              <a:ext cx="64008" cy="64008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08BBF2B4-5272-405A-9A87-3DA4866713B8}"/>
              </a:ext>
            </a:extLst>
          </p:cNvPr>
          <p:cNvSpPr txBox="1"/>
          <p:nvPr/>
        </p:nvSpPr>
        <p:spPr>
          <a:xfrm>
            <a:off x="199911" y="278063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5F25F6A-845E-4ECB-ADAF-E7C9470DD294}"/>
              </a:ext>
            </a:extLst>
          </p:cNvPr>
          <p:cNvSpPr txBox="1"/>
          <p:nvPr/>
        </p:nvSpPr>
        <p:spPr>
          <a:xfrm>
            <a:off x="3089819" y="240436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37EB76E-06CC-47C8-9025-EC1C4BEF4958}"/>
              </a:ext>
            </a:extLst>
          </p:cNvPr>
          <p:cNvSpPr txBox="1"/>
          <p:nvPr/>
        </p:nvSpPr>
        <p:spPr>
          <a:xfrm>
            <a:off x="5995422" y="241968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723FF30-29DC-40C4-BFD9-9B722867B723}"/>
              </a:ext>
            </a:extLst>
          </p:cNvPr>
          <p:cNvSpPr txBox="1"/>
          <p:nvPr/>
        </p:nvSpPr>
        <p:spPr>
          <a:xfrm>
            <a:off x="533688" y="3266219"/>
            <a:ext cx="24040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1 (21%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60CA60B-BFE9-4B2C-95EC-A01F16E98E71}"/>
              </a:ext>
            </a:extLst>
          </p:cNvPr>
          <p:cNvSpPr txBox="1"/>
          <p:nvPr/>
        </p:nvSpPr>
        <p:spPr>
          <a:xfrm rot="16200000">
            <a:off x="-982196" y="1725781"/>
            <a:ext cx="2404095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(30%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723FF30-29DC-40C4-BFD9-9B722867B723}"/>
              </a:ext>
            </a:extLst>
          </p:cNvPr>
          <p:cNvSpPr txBox="1"/>
          <p:nvPr/>
        </p:nvSpPr>
        <p:spPr>
          <a:xfrm>
            <a:off x="3524152" y="3214199"/>
            <a:ext cx="24040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1 (33%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160CA60B-BFE9-4B2C-95EC-A01F16E98E71}"/>
              </a:ext>
            </a:extLst>
          </p:cNvPr>
          <p:cNvSpPr txBox="1"/>
          <p:nvPr/>
        </p:nvSpPr>
        <p:spPr>
          <a:xfrm rot="16200000">
            <a:off x="2612507" y="1645847"/>
            <a:ext cx="1209780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(16%)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6723FF30-29DC-40C4-BFD9-9B722867B723}"/>
              </a:ext>
            </a:extLst>
          </p:cNvPr>
          <p:cNvSpPr txBox="1"/>
          <p:nvPr/>
        </p:nvSpPr>
        <p:spPr>
          <a:xfrm>
            <a:off x="6510206" y="3236258"/>
            <a:ext cx="240409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1 (26%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60CA60B-BFE9-4B2C-95EC-A01F16E98E71}"/>
              </a:ext>
            </a:extLst>
          </p:cNvPr>
          <p:cNvSpPr txBox="1"/>
          <p:nvPr/>
        </p:nvSpPr>
        <p:spPr>
          <a:xfrm rot="16200000">
            <a:off x="4911717" y="1694309"/>
            <a:ext cx="2404095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PC 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SG" sz="1200" dirty="0">
                <a:latin typeface="Arial" panose="020B0604020202020204" pitchFamily="34" charset="0"/>
                <a:cs typeface="Arial" panose="020B0604020202020204" pitchFamily="34" charset="0"/>
              </a:rPr>
              <a:t> (33%)</a:t>
            </a:r>
          </a:p>
        </p:txBody>
      </p:sp>
      <p:graphicFrame>
        <p:nvGraphicFramePr>
          <p:cNvPr id="35" name="Chart 34">
            <a:extLst>
              <a:ext uri="{FF2B5EF4-FFF2-40B4-BE49-F238E27FC236}">
                <a16:creationId xmlns:a16="http://schemas.microsoft.com/office/drawing/2014/main" id="{E7F8F9CF-3335-4A44-9D61-B847D6C23CB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27783834"/>
              </p:ext>
            </p:extLst>
          </p:nvPr>
        </p:nvGraphicFramePr>
        <p:xfrm>
          <a:off x="6108909" y="4046854"/>
          <a:ext cx="3009857" cy="23812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37" name="Chart 36">
            <a:extLst>
              <a:ext uri="{FF2B5EF4-FFF2-40B4-BE49-F238E27FC236}">
                <a16:creationId xmlns:a16="http://schemas.microsoft.com/office/drawing/2014/main" id="{FA17AD40-6024-0D43-94FA-E8F22220DDB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9398131"/>
              </p:ext>
            </p:extLst>
          </p:nvPr>
        </p:nvGraphicFramePr>
        <p:xfrm>
          <a:off x="3286067" y="3980561"/>
          <a:ext cx="2778118" cy="265191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38" name="TextBox 37">
            <a:extLst>
              <a:ext uri="{FF2B5EF4-FFF2-40B4-BE49-F238E27FC236}">
                <a16:creationId xmlns:a16="http://schemas.microsoft.com/office/drawing/2014/main" id="{08BBF2B4-5272-405A-9A87-3DA4866713B8}"/>
              </a:ext>
            </a:extLst>
          </p:cNvPr>
          <p:cNvSpPr txBox="1"/>
          <p:nvPr/>
        </p:nvSpPr>
        <p:spPr>
          <a:xfrm>
            <a:off x="196197" y="3642007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45F25F6A-845E-4ECB-ADAF-E7C9470DD294}"/>
              </a:ext>
            </a:extLst>
          </p:cNvPr>
          <p:cNvSpPr txBox="1"/>
          <p:nvPr/>
        </p:nvSpPr>
        <p:spPr>
          <a:xfrm>
            <a:off x="3086105" y="3604380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D37EB76E-06CC-47C8-9025-EC1C4BEF4958}"/>
              </a:ext>
            </a:extLst>
          </p:cNvPr>
          <p:cNvSpPr txBox="1"/>
          <p:nvPr/>
        </p:nvSpPr>
        <p:spPr>
          <a:xfrm>
            <a:off x="5991708" y="3605912"/>
            <a:ext cx="251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SG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SG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32041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1650504-F82F-4050-BA29-3D9E8D64C632}"/>
              </a:ext>
            </a:extLst>
          </p:cNvPr>
          <p:cNvSpPr txBox="1"/>
          <p:nvPr/>
        </p:nvSpPr>
        <p:spPr>
          <a:xfrm>
            <a:off x="-13865" y="150449"/>
            <a:ext cx="4359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EEAC8A0-696F-4227-A6CE-675BE9E0BFE7}"/>
              </a:ext>
            </a:extLst>
          </p:cNvPr>
          <p:cNvGrpSpPr/>
          <p:nvPr/>
        </p:nvGrpSpPr>
        <p:grpSpPr>
          <a:xfrm>
            <a:off x="1344453" y="519781"/>
            <a:ext cx="6499067" cy="5703803"/>
            <a:chOff x="1344453" y="519781"/>
            <a:chExt cx="4441273" cy="3897813"/>
          </a:xfrm>
        </p:grpSpPr>
        <p:pic>
          <p:nvPicPr>
            <p:cNvPr id="5" name="Picture 2">
              <a:extLst>
                <a:ext uri="{FF2B5EF4-FFF2-40B4-BE49-F238E27FC236}">
                  <a16:creationId xmlns:a16="http://schemas.microsoft.com/office/drawing/2014/main" id="{178C361A-884E-410E-AA92-4B5D56D9EBD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684" b="2747"/>
            <a:stretch/>
          </p:blipFill>
          <p:spPr bwMode="auto">
            <a:xfrm>
              <a:off x="1344453" y="519781"/>
              <a:ext cx="4441273" cy="38978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4BCED0A9-13F0-4303-8DCB-FD3930870F83}"/>
                </a:ext>
              </a:extLst>
            </p:cNvPr>
            <p:cNvSpPr txBox="1"/>
            <p:nvPr/>
          </p:nvSpPr>
          <p:spPr>
            <a:xfrm>
              <a:off x="3110947" y="1298010"/>
              <a:ext cx="439118" cy="231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E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EA6E2280-A14D-487C-A454-8C651B4AEA2B}"/>
                </a:ext>
              </a:extLst>
            </p:cNvPr>
            <p:cNvSpPr txBox="1"/>
            <p:nvPr/>
          </p:nvSpPr>
          <p:spPr>
            <a:xfrm>
              <a:off x="2365230" y="2814374"/>
              <a:ext cx="359526" cy="2313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IE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DA00F14-7F32-4946-AC1D-2BF1968035B3}"/>
                </a:ext>
              </a:extLst>
            </p:cNvPr>
            <p:cNvSpPr txBox="1"/>
            <p:nvPr/>
          </p:nvSpPr>
          <p:spPr>
            <a:xfrm>
              <a:off x="4640190" y="2016085"/>
              <a:ext cx="328853" cy="2313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OE</a:t>
              </a:r>
            </a:p>
          </p:txBody>
        </p:sp>
        <p:sp>
          <p:nvSpPr>
            <p:cNvPr id="9" name="Oval 8">
              <a:extLst>
                <a:ext uri="{FF2B5EF4-FFF2-40B4-BE49-F238E27FC236}">
                  <a16:creationId xmlns:a16="http://schemas.microsoft.com/office/drawing/2014/main" id="{76D5F810-75EB-4C2F-94EF-5F78C9666910}"/>
                </a:ext>
              </a:extLst>
            </p:cNvPr>
            <p:cNvSpPr/>
            <p:nvPr/>
          </p:nvSpPr>
          <p:spPr>
            <a:xfrm>
              <a:off x="3421089" y="1385368"/>
              <a:ext cx="144000" cy="14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10" name="Oval 9">
              <a:extLst>
                <a:ext uri="{FF2B5EF4-FFF2-40B4-BE49-F238E27FC236}">
                  <a16:creationId xmlns:a16="http://schemas.microsoft.com/office/drawing/2014/main" id="{9E7B0D0E-7B2B-4518-973F-81B15A528C8D}"/>
                </a:ext>
              </a:extLst>
            </p:cNvPr>
            <p:cNvSpPr/>
            <p:nvPr/>
          </p:nvSpPr>
          <p:spPr>
            <a:xfrm>
              <a:off x="4721505" y="2324687"/>
              <a:ext cx="144000" cy="14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CF9F3ED2-13AD-4986-AE89-F24B2B236B0B}"/>
                </a:ext>
              </a:extLst>
            </p:cNvPr>
            <p:cNvSpPr/>
            <p:nvPr/>
          </p:nvSpPr>
          <p:spPr>
            <a:xfrm>
              <a:off x="2731699" y="2799939"/>
              <a:ext cx="144000" cy="144000"/>
            </a:xfrm>
            <a:prstGeom prst="ellipse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SG"/>
            </a:p>
          </p:txBody>
        </p:sp>
      </p:grpSp>
    </p:spTree>
    <p:extLst>
      <p:ext uri="{BB962C8B-B14F-4D97-AF65-F5344CB8AC3E}">
        <p14:creationId xmlns:p14="http://schemas.microsoft.com/office/powerpoint/2010/main" val="3395301180"/>
      </p:ext>
    </p:extLst>
  </p:cSld>
  <p:clrMapOvr>
    <a:masterClrMapping/>
  </p:clrMapOvr>
</p:sld>
</file>

<file path=ppt/theme/theme1.xml><?xml version="1.0" encoding="utf-8"?>
<a:theme xmlns:a="http://schemas.openxmlformats.org/drawingml/2006/main" name="Theme3.2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heme3.2" id="{5F8F90EC-9A7A-402E-8568-7C2698AC5CD5}" vid="{37F91303-9AB7-48A2-ACEC-BF967F55140B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700</TotalTime>
  <Words>169</Words>
  <Application>Microsoft Office PowerPoint</Application>
  <PresentationFormat>On-screen Show (4:3)</PresentationFormat>
  <Paragraphs>2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eme3.2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ie Hou Lee</dc:creator>
  <cp:lastModifiedBy>Yie Hou Lee</cp:lastModifiedBy>
  <cp:revision>22</cp:revision>
  <dcterms:created xsi:type="dcterms:W3CDTF">2019-06-18T08:53:40Z</dcterms:created>
  <dcterms:modified xsi:type="dcterms:W3CDTF">2019-07-24T08:42:05Z</dcterms:modified>
</cp:coreProperties>
</file>